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8.jpeg" ContentType="image/jpeg"/>
  <Override PartName="/ppt/media/image5.png" ContentType="image/png"/>
  <Override PartName="/ppt/media/image16.png" ContentType="image/png"/>
  <Override PartName="/ppt/media/image15.jpeg" ContentType="image/jpeg"/>
  <Override PartName="/ppt/media/image14.jpeg" ContentType="image/jpeg"/>
  <Override PartName="/ppt/media/image2.png" ContentType="image/png"/>
  <Override PartName="/ppt/media/image1.jpeg" ContentType="image/jpeg"/>
  <Override PartName="/ppt/media/image3.png" ContentType="image/png"/>
  <Override PartName="/ppt/media/image4.png" ContentType="image/png"/>
  <Override PartName="/ppt/media/image13.jpeg" ContentType="image/jpeg"/>
  <Override PartName="/ppt/media/image6.jpeg" ContentType="image/jpeg"/>
  <Override PartName="/ppt/media/image9.jpeg" ContentType="image/jpeg"/>
  <Override PartName="/ppt/media/image11.jpeg" ContentType="image/jpeg"/>
  <Override PartName="/ppt/media/image7.jpeg" ContentType="image/jpeg"/>
  <Override PartName="/ppt/media/image1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12696825" cy="75057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9FAE57-3272-45AB-A187-B132E6A3B9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4680" y="1750680"/>
            <a:ext cx="1142676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4680" y="4338720"/>
            <a:ext cx="1142676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5484C-B8EA-4E4E-A4F6-563CE32308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4680" y="175068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490080" y="175068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4680" y="433872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490080" y="433872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82830B-5773-4A37-9E42-D9013767B2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4680" y="1750680"/>
            <a:ext cx="367920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498200" y="1750680"/>
            <a:ext cx="367920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361720" y="1750680"/>
            <a:ext cx="367920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4680" y="4338720"/>
            <a:ext cx="367920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498200" y="4338720"/>
            <a:ext cx="367920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361720" y="4338720"/>
            <a:ext cx="367920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6FDEF-B56F-40EF-9716-3285D87DC90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4680" y="1750680"/>
            <a:ext cx="11426760" cy="4954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482E4-3E19-4AD5-B8ED-3AF37BA821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4680" y="1750680"/>
            <a:ext cx="11426760" cy="495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1ED997-211B-40E6-A180-67EC2796D7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4680" y="1750680"/>
            <a:ext cx="5576040" cy="495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490080" y="1750680"/>
            <a:ext cx="5576040" cy="495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0A3029-ECB1-4A7B-9733-FA5478468A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0E809C-C15C-4711-BABC-E97C011CFA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4680" y="299520"/>
            <a:ext cx="11426760" cy="5800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64"/>
              </a:spcBef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D81BBE-6F66-4503-8DBB-4FD9184663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4680" y="175068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490080" y="1750680"/>
            <a:ext cx="5576040" cy="495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4680" y="433872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76F6B0-EE41-4C91-90CF-44E5F352AF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4680" y="1750680"/>
            <a:ext cx="5576040" cy="495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490080" y="175068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490080" y="433872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802BE-9DCC-4116-8DED-0096A94F3A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4680" y="175068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490080" y="1750680"/>
            <a:ext cx="557604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4680" y="4338720"/>
            <a:ext cx="11426760" cy="236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64"/>
              </a:spcBef>
              <a:buNone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E261F-DF6D-40A4-A80B-1928941B62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4680" y="299520"/>
            <a:ext cx="11426760" cy="125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4680" y="1750680"/>
            <a:ext cx="11426760" cy="495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74760" indent="-374760">
              <a:spcBef>
                <a:spcPts val="964"/>
              </a:spcBef>
              <a:buClr>
                <a:srgbClr val="000000"/>
              </a:buClr>
              <a:buFont typeface="Arial"/>
              <a:buChar char="•"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  <a:p>
            <a:pPr lvl="1" marL="500040" indent="500040">
              <a:spcBef>
                <a:spcPts val="964"/>
              </a:spcBef>
              <a:buClr>
                <a:srgbClr val="000000"/>
              </a:buClr>
              <a:buFont typeface="Arial"/>
              <a:buChar char="–"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  <a:p>
            <a:pPr lvl="2" marL="1000080">
              <a:spcBef>
                <a:spcPts val="964"/>
              </a:spcBef>
              <a:buClr>
                <a:srgbClr val="000000"/>
              </a:buClr>
              <a:buFont typeface="Arial"/>
              <a:buChar char="•"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  <a:p>
            <a:pPr lvl="3" marL="1501920" indent="-501840">
              <a:spcBef>
                <a:spcPts val="964"/>
              </a:spcBef>
              <a:buClr>
                <a:srgbClr val="000000"/>
              </a:buClr>
              <a:buFont typeface="Arial"/>
              <a:buChar char="–"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  <a:p>
            <a:pPr lvl="4" marL="2001960" indent="-1001880">
              <a:spcBef>
                <a:spcPts val="964"/>
              </a:spcBef>
              <a:buClr>
                <a:srgbClr val="000000"/>
              </a:buClr>
              <a:buFont typeface="Arial"/>
              <a:buChar char="»"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  <a:p>
            <a:pPr lvl="5" marL="2001960" indent="-1001880">
              <a:spcBef>
                <a:spcPts val="964"/>
              </a:spcBef>
              <a:buClr>
                <a:srgbClr val="000000"/>
              </a:buClr>
              <a:buFont typeface="Arial"/>
              <a:buChar char="»"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  <a:p>
            <a:pPr lvl="6" marL="2001960" indent="-1001880">
              <a:spcBef>
                <a:spcPts val="964"/>
              </a:spcBef>
              <a:buClr>
                <a:srgbClr val="000000"/>
              </a:buClr>
              <a:buFont typeface="Arial"/>
              <a:buChar char="»"/>
              <a:tabLst>
                <a:tab algn="l" pos="1000080"/>
                <a:tab algn="l" pos="2000160"/>
                <a:tab algn="l" pos="3000240"/>
                <a:tab algn="l" pos="4000680"/>
                <a:tab algn="l" pos="5000760"/>
                <a:tab algn="l" pos="6000840"/>
                <a:tab algn="l" pos="7000920"/>
                <a:tab algn="l" pos="8001000"/>
                <a:tab algn="l" pos="9001080"/>
                <a:tab algn="l" pos="1000116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5040" y="6835320"/>
            <a:ext cx="2962080" cy="5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338720" y="6835320"/>
            <a:ext cx="4021200" cy="5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099720" y="6835320"/>
            <a:ext cx="2962080" cy="5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5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680C50-C055-497F-8F57-3945D19EB606}" type="slidenum">
              <a:rPr b="0" lang="zh-CN" sz="15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jpeg"/><Relationship Id="rId3" Type="http://schemas.openxmlformats.org/officeDocument/2006/relationships/image" Target="../media/image8.jpeg"/><Relationship Id="rId4" Type="http://schemas.openxmlformats.org/officeDocument/2006/relationships/image" Target="../media/image9.jpeg"/><Relationship Id="rId5" Type="http://schemas.openxmlformats.org/officeDocument/2006/relationships/image" Target="../media/image10.jpeg"/><Relationship Id="rId6" Type="http://schemas.openxmlformats.org/officeDocument/2006/relationships/image" Target="../media/image11.jpeg"/><Relationship Id="rId7" Type="http://schemas.openxmlformats.org/officeDocument/2006/relationships/image" Target="../media/image12.jpeg"/><Relationship Id="rId8" Type="http://schemas.openxmlformats.org/officeDocument/2006/relationships/image" Target="../media/image13.jpeg"/><Relationship Id="rId9" Type="http://schemas.openxmlformats.org/officeDocument/2006/relationships/image" Target="../media/image14.jpeg"/><Relationship Id="rId10" Type="http://schemas.openxmlformats.org/officeDocument/2006/relationships/image" Target="../media/image15.jpeg"/><Relationship Id="rId1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3" descr="相关性分析"/>
          <p:cNvPicPr/>
          <p:nvPr/>
        </p:nvPicPr>
        <p:blipFill>
          <a:blip r:embed="rId1"/>
          <a:stretch/>
        </p:blipFill>
        <p:spPr>
          <a:xfrm>
            <a:off x="598320" y="293760"/>
            <a:ext cx="10793520" cy="5865840"/>
          </a:xfrm>
          <a:prstGeom prst="rect">
            <a:avLst/>
          </a:prstGeom>
          <a:ln w="0">
            <a:noFill/>
          </a:ln>
        </p:spPr>
      </p:pic>
      <p:sp>
        <p:nvSpPr>
          <p:cNvPr id="42" name="文本框 4"/>
          <p:cNvSpPr/>
          <p:nvPr/>
        </p:nvSpPr>
        <p:spPr>
          <a:xfrm>
            <a:off x="598320" y="6159600"/>
            <a:ext cx="10793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Figure.S1:Correlation analysis under different time flooding stress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(ws_0h_1, 2, 3 (flooding treated for 0 h), ws_8h_1, 2, 3 (flood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ing treated for 8 h), ws_24h_1, 2, 3 (flooding treated for 24 h)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片 1" descr="VPCvsVPA"/>
          <p:cNvPicPr/>
          <p:nvPr/>
        </p:nvPicPr>
        <p:blipFill>
          <a:blip r:embed="rId1"/>
          <a:stretch/>
        </p:blipFill>
        <p:spPr>
          <a:xfrm>
            <a:off x="-365040" y="15840"/>
            <a:ext cx="6835680" cy="6480360"/>
          </a:xfrm>
          <a:prstGeom prst="rect">
            <a:avLst/>
          </a:prstGeom>
          <a:ln w="0">
            <a:noFill/>
          </a:ln>
        </p:spPr>
      </p:pic>
      <p:pic>
        <p:nvPicPr>
          <p:cNvPr id="44" name="图片 6" descr="VPEvsVPA"/>
          <p:cNvPicPr/>
          <p:nvPr/>
        </p:nvPicPr>
        <p:blipFill>
          <a:blip r:embed="rId2"/>
          <a:stretch/>
        </p:blipFill>
        <p:spPr>
          <a:xfrm>
            <a:off x="6242040" y="15840"/>
            <a:ext cx="7137360" cy="6480360"/>
          </a:xfrm>
          <a:prstGeom prst="rect">
            <a:avLst/>
          </a:prstGeom>
          <a:ln w="0">
            <a:noFill/>
          </a:ln>
        </p:spPr>
      </p:pic>
      <p:sp>
        <p:nvSpPr>
          <p:cNvPr id="45" name="文本框 7"/>
          <p:cNvSpPr/>
          <p:nvPr/>
        </p:nvSpPr>
        <p:spPr>
          <a:xfrm>
            <a:off x="-65160" y="6684840"/>
            <a:ext cx="128286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Figure.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: Functional annotation and classification of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o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rchardgrassGO enrichment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"*" is an enriched GO term,A:down-regulated differential genes comparison between 8 h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lood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ing treatment and 0h treatment (CK); B up-regulated differential genes comparison between 24 h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lood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ing treatment and 0 h treatme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图片 1" descr="VPCvsVPA柱状"/>
          <p:cNvPicPr/>
          <p:nvPr/>
        </p:nvPicPr>
        <p:blipFill>
          <a:blip r:embed="rId1"/>
          <a:stretch/>
        </p:blipFill>
        <p:spPr>
          <a:xfrm>
            <a:off x="-639720" y="-66600"/>
            <a:ext cx="13876200" cy="3411360"/>
          </a:xfrm>
          <a:prstGeom prst="rect">
            <a:avLst/>
          </a:prstGeom>
          <a:ln w="0">
            <a:noFill/>
          </a:ln>
        </p:spPr>
      </p:pic>
      <p:pic>
        <p:nvPicPr>
          <p:cNvPr id="47" name="图片 2" descr="VPEvsVPAZH柱状"/>
          <p:cNvPicPr/>
          <p:nvPr/>
        </p:nvPicPr>
        <p:blipFill>
          <a:blip r:embed="rId2"/>
          <a:stretch/>
        </p:blipFill>
        <p:spPr>
          <a:xfrm>
            <a:off x="-639720" y="3344760"/>
            <a:ext cx="13876200" cy="3508560"/>
          </a:xfrm>
          <a:prstGeom prst="rect">
            <a:avLst/>
          </a:prstGeom>
          <a:ln w="0">
            <a:noFill/>
          </a:ln>
        </p:spPr>
      </p:pic>
      <p:sp>
        <p:nvSpPr>
          <p:cNvPr id="48" name="文本框 3"/>
          <p:cNvSpPr/>
          <p:nvPr/>
        </p:nvSpPr>
        <p:spPr>
          <a:xfrm>
            <a:off x="33480" y="6853320"/>
            <a:ext cx="12687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Figure 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3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. GO functional classification of the control and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lood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ing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stress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orchardgrass seedling. (A) comparison between 8 h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looding 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and 0 h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looding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(CK); (B) comparison between 24 h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looding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and 0 h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looding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(CK)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图片 1" descr="evm.model.Contig1330.361"/>
          <p:cNvPicPr/>
          <p:nvPr/>
        </p:nvPicPr>
        <p:blipFill>
          <a:blip r:embed="rId1"/>
          <a:srcRect l="0" t="0" r="0" b="17978"/>
          <a:stretch/>
        </p:blipFill>
        <p:spPr>
          <a:xfrm>
            <a:off x="65160" y="28440"/>
            <a:ext cx="2879640" cy="2411640"/>
          </a:xfrm>
          <a:prstGeom prst="rect">
            <a:avLst/>
          </a:prstGeom>
          <a:ln w="0">
            <a:noFill/>
          </a:ln>
        </p:spPr>
      </p:pic>
      <p:pic>
        <p:nvPicPr>
          <p:cNvPr id="50" name="图片 2" descr="evm.model.Contig1390.761"/>
          <p:cNvPicPr/>
          <p:nvPr/>
        </p:nvPicPr>
        <p:blipFill>
          <a:blip r:embed="rId2"/>
          <a:srcRect l="0" t="0" r="0" b="16427"/>
          <a:stretch/>
        </p:blipFill>
        <p:spPr>
          <a:xfrm>
            <a:off x="3441600" y="28440"/>
            <a:ext cx="2881440" cy="2411640"/>
          </a:xfrm>
          <a:prstGeom prst="rect">
            <a:avLst/>
          </a:prstGeom>
          <a:ln w="0">
            <a:noFill/>
          </a:ln>
        </p:spPr>
      </p:pic>
      <p:pic>
        <p:nvPicPr>
          <p:cNvPr id="51" name="图片 3" descr="evm.model.Contig242.1811"/>
          <p:cNvPicPr/>
          <p:nvPr/>
        </p:nvPicPr>
        <p:blipFill>
          <a:blip r:embed="rId3"/>
          <a:srcRect l="0" t="0" r="0" b="16605"/>
          <a:stretch/>
        </p:blipFill>
        <p:spPr>
          <a:xfrm>
            <a:off x="6543720" y="28440"/>
            <a:ext cx="2879640" cy="2411640"/>
          </a:xfrm>
          <a:prstGeom prst="rect">
            <a:avLst/>
          </a:prstGeom>
          <a:ln w="0">
            <a:noFill/>
          </a:ln>
        </p:spPr>
      </p:pic>
      <p:pic>
        <p:nvPicPr>
          <p:cNvPr id="52" name="图片 4" descr="evm.model.Contig343.841"/>
          <p:cNvPicPr/>
          <p:nvPr/>
        </p:nvPicPr>
        <p:blipFill>
          <a:blip r:embed="rId4"/>
          <a:srcRect l="0" t="0" r="0" b="14715"/>
          <a:stretch/>
        </p:blipFill>
        <p:spPr>
          <a:xfrm>
            <a:off x="9607680" y="28440"/>
            <a:ext cx="2879640" cy="2411640"/>
          </a:xfrm>
          <a:prstGeom prst="rect">
            <a:avLst/>
          </a:prstGeom>
          <a:ln w="0">
            <a:noFill/>
          </a:ln>
        </p:spPr>
      </p:pic>
      <p:pic>
        <p:nvPicPr>
          <p:cNvPr id="53" name="图片 5" descr="evm.model.Contig477.3191"/>
          <p:cNvPicPr/>
          <p:nvPr/>
        </p:nvPicPr>
        <p:blipFill>
          <a:blip r:embed="rId5"/>
          <a:srcRect l="0" t="0" r="0" b="16863"/>
          <a:stretch/>
        </p:blipFill>
        <p:spPr>
          <a:xfrm>
            <a:off x="65160" y="2548080"/>
            <a:ext cx="2879640" cy="2412720"/>
          </a:xfrm>
          <a:prstGeom prst="rect">
            <a:avLst/>
          </a:prstGeom>
          <a:ln w="0">
            <a:noFill/>
          </a:ln>
        </p:spPr>
      </p:pic>
      <p:pic>
        <p:nvPicPr>
          <p:cNvPr id="54" name="图片 6" descr="evm.model.Contig520.1091"/>
          <p:cNvPicPr/>
          <p:nvPr/>
        </p:nvPicPr>
        <p:blipFill>
          <a:blip r:embed="rId6"/>
          <a:srcRect l="0" t="0" r="0" b="16863"/>
          <a:stretch/>
        </p:blipFill>
        <p:spPr>
          <a:xfrm>
            <a:off x="3441600" y="2548080"/>
            <a:ext cx="2881440" cy="2412720"/>
          </a:xfrm>
          <a:prstGeom prst="rect">
            <a:avLst/>
          </a:prstGeom>
          <a:ln w="0">
            <a:noFill/>
          </a:ln>
        </p:spPr>
      </p:pic>
      <p:pic>
        <p:nvPicPr>
          <p:cNvPr id="55" name="图片 7" descr="evm.model.Contig77.721"/>
          <p:cNvPicPr/>
          <p:nvPr/>
        </p:nvPicPr>
        <p:blipFill>
          <a:blip r:embed="rId7"/>
          <a:srcRect l="0" t="0" r="0" b="16201"/>
          <a:stretch/>
        </p:blipFill>
        <p:spPr>
          <a:xfrm>
            <a:off x="6429240" y="2440080"/>
            <a:ext cx="2880000" cy="2411280"/>
          </a:xfrm>
          <a:prstGeom prst="rect">
            <a:avLst/>
          </a:prstGeom>
          <a:ln w="0">
            <a:noFill/>
          </a:ln>
        </p:spPr>
      </p:pic>
      <p:pic>
        <p:nvPicPr>
          <p:cNvPr id="56" name="图片 14" descr="evm.model.Contig260.1521"/>
          <p:cNvPicPr/>
          <p:nvPr/>
        </p:nvPicPr>
        <p:blipFill>
          <a:blip r:embed="rId8"/>
          <a:srcRect l="0" t="0" r="0" b="16007"/>
          <a:stretch/>
        </p:blipFill>
        <p:spPr>
          <a:xfrm>
            <a:off x="65160" y="5030640"/>
            <a:ext cx="2879640" cy="2413080"/>
          </a:xfrm>
          <a:prstGeom prst="rect">
            <a:avLst/>
          </a:prstGeom>
          <a:ln w="0">
            <a:noFill/>
          </a:ln>
        </p:spPr>
      </p:pic>
      <p:pic>
        <p:nvPicPr>
          <p:cNvPr id="57" name="图片 15" descr="evm.model.Contig163.1501"/>
          <p:cNvPicPr/>
          <p:nvPr/>
        </p:nvPicPr>
        <p:blipFill>
          <a:blip r:embed="rId9"/>
          <a:srcRect l="0" t="0" r="0" b="15781"/>
          <a:stretch/>
        </p:blipFill>
        <p:spPr>
          <a:xfrm>
            <a:off x="9607680" y="2548080"/>
            <a:ext cx="2879640" cy="2412720"/>
          </a:xfrm>
          <a:prstGeom prst="rect">
            <a:avLst/>
          </a:prstGeom>
          <a:ln w="0">
            <a:noFill/>
          </a:ln>
        </p:spPr>
      </p:pic>
      <p:pic>
        <p:nvPicPr>
          <p:cNvPr id="58" name="图片 16" descr="evm.model.Contig716.2201"/>
          <p:cNvPicPr/>
          <p:nvPr/>
        </p:nvPicPr>
        <p:blipFill>
          <a:blip r:embed="rId10"/>
          <a:srcRect l="0" t="0" r="0" b="10564"/>
          <a:stretch/>
        </p:blipFill>
        <p:spPr>
          <a:xfrm>
            <a:off x="3441600" y="5030640"/>
            <a:ext cx="2881440" cy="2413080"/>
          </a:xfrm>
          <a:prstGeom prst="rect">
            <a:avLst/>
          </a:prstGeom>
          <a:ln w="0">
            <a:noFill/>
          </a:ln>
        </p:spPr>
      </p:pic>
      <p:sp>
        <p:nvSpPr>
          <p:cNvPr id="59" name="文本框 17"/>
          <p:cNvSpPr/>
          <p:nvPr/>
        </p:nvSpPr>
        <p:spPr>
          <a:xfrm>
            <a:off x="7211880" y="6281640"/>
            <a:ext cx="465948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Figure 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4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.qPCR verification results: relative expression of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ten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differential genes in 0 h (CK), 8 h and 24 h samples and relative expression in non-stressed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(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0h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)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seedlings was set as 1.0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图片 2" descr="回归图4"/>
          <p:cNvPicPr/>
          <p:nvPr/>
        </p:nvPicPr>
        <p:blipFill>
          <a:blip r:embed="rId1"/>
          <a:srcRect l="10464" t="0" r="12569" b="5810"/>
          <a:stretch/>
        </p:blipFill>
        <p:spPr>
          <a:xfrm>
            <a:off x="1609560" y="128520"/>
            <a:ext cx="7572600" cy="5904000"/>
          </a:xfrm>
          <a:prstGeom prst="rect">
            <a:avLst/>
          </a:prstGeom>
          <a:ln w="0">
            <a:noFill/>
          </a:ln>
        </p:spPr>
      </p:pic>
      <p:sp>
        <p:nvSpPr>
          <p:cNvPr id="61" name="文本框 3"/>
          <p:cNvSpPr/>
          <p:nvPr/>
        </p:nvSpPr>
        <p:spPr>
          <a:xfrm>
            <a:off x="922320" y="6458040"/>
            <a:ext cx="1017756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Figure 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5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. Correlation between qRT-PCR and RNA sequencing for the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ten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selected  genes. Data was log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transformed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7-13T05:22:57Z</dcterms:created>
  <dc:creator>Administrator</dc:creator>
  <dc:description/>
  <dc:language>en-US</dc:language>
  <cp:lastModifiedBy>伊翁</cp:lastModifiedBy>
  <dcterms:modified xsi:type="dcterms:W3CDTF">2020-03-19T07:07:46Z</dcterms:modified>
  <cp:revision>25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3.0.8775</vt:lpwstr>
  </property>
</Properties>
</file>